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82546DAC-90F5-4ADB-836A-93D37522A805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6840" y="396216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8FA2E22-8BE5-4D41-94F1-159E17353385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24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1738444-28AB-426E-AF5E-67F39C6E9F72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820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19560" y="159984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684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820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19560" y="3962160"/>
            <a:ext cx="264852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974162A-72C7-4217-831B-ABF0060D2038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6D1B7768-5EEB-4DD0-BBCE-620E243AAAD1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C137477-0390-4C76-B3D6-66918A616992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7C4D285-53F9-4B4B-8378-C683004B5611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9CA3482-5E40-4FF4-B746-0CD478308F39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6840" y="274680"/>
            <a:ext cx="8226360" cy="528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D1CEF90-42FD-4855-A2FB-8A92C91C0F41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3383CEB-2454-4EC7-8B6F-F25242CCDEB3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2440" y="396216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1007CB5B-D326-49BC-89BF-5C650E165957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68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2440" y="1599840"/>
            <a:ext cx="4014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6840" y="3962160"/>
            <a:ext cx="8226360" cy="215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C62CFA2-F5DC-40A8-983B-60A1850C61B0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6840" y="274680"/>
            <a:ext cx="8226360" cy="113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6840" y="1599840"/>
            <a:ext cx="8226360" cy="4522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57200" y="6245280"/>
            <a:ext cx="213372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124080" y="6245280"/>
            <a:ext cx="289584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6553080" y="6245280"/>
            <a:ext cx="2130480" cy="473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83B9A4D9-584D-4B0D-A98C-E4848F117C2E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2.png"/><Relationship Id="rId6" Type="http://schemas.openxmlformats.org/officeDocument/2006/relationships/image" Target="../media/image2.png"/><Relationship Id="rId7" Type="http://schemas.openxmlformats.org/officeDocument/2006/relationships/image" Target="../media/image3.png"/><Relationship Id="rId8" Type="http://schemas.openxmlformats.org/officeDocument/2006/relationships/image" Target="../media/image4.png"/><Relationship Id="rId9" Type="http://schemas.openxmlformats.org/officeDocument/2006/relationships/image" Target="../media/image5.png"/><Relationship Id="rId10" Type="http://schemas.openxmlformats.org/officeDocument/2006/relationships/image" Target="../media/image2.png"/><Relationship Id="rId11" Type="http://schemas.openxmlformats.org/officeDocument/2006/relationships/image" Target="../media/image3.png"/><Relationship Id="rId12" Type="http://schemas.openxmlformats.org/officeDocument/2006/relationships/image" Target="../media/image4.png"/><Relationship Id="rId13" Type="http://schemas.openxmlformats.org/officeDocument/2006/relationships/image" Target="../media/image5.png"/><Relationship Id="rId14" Type="http://schemas.openxmlformats.org/officeDocument/2006/relationships/image" Target="../media/image2.png"/><Relationship Id="rId15" Type="http://schemas.openxmlformats.org/officeDocument/2006/relationships/image" Target="../media/image2.png"/><Relationship Id="rId16" Type="http://schemas.openxmlformats.org/officeDocument/2006/relationships/image" Target="../media/image3.png"/><Relationship Id="rId17" Type="http://schemas.openxmlformats.org/officeDocument/2006/relationships/image" Target="../media/image4.png"/><Relationship Id="rId18" Type="http://schemas.openxmlformats.org/officeDocument/2006/relationships/image" Target="../media/image5.png"/><Relationship Id="rId19" Type="http://schemas.openxmlformats.org/officeDocument/2006/relationships/image" Target="../media/image2.png"/><Relationship Id="rId20" Type="http://schemas.openxmlformats.org/officeDocument/2006/relationships/image" Target="../media/image4.png"/><Relationship Id="rId21" Type="http://schemas.openxmlformats.org/officeDocument/2006/relationships/image" Target="../media/image3.png"/><Relationship Id="rId22" Type="http://schemas.openxmlformats.org/officeDocument/2006/relationships/image" Target="../media/image3.png"/><Relationship Id="rId23" Type="http://schemas.openxmlformats.org/officeDocument/2006/relationships/image" Target="../media/image3.png"/><Relationship Id="rId24" Type="http://schemas.openxmlformats.org/officeDocument/2006/relationships/image" Target="../media/image4.png"/><Relationship Id="rId2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909880" y="270000"/>
            <a:ext cx="5319720" cy="65070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4000" y="722160"/>
            <a:ext cx="3527280" cy="76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Li et al.,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dditional file 1:  Figure S1A.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624760" y="763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1154160" y="2238480"/>
            <a:ext cx="167328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HBc/e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1814-2456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657680" y="1862280"/>
            <a:ext cx="307656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preS1, preS2, HBs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(2854-3215-832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154160" y="2571840"/>
            <a:ext cx="192240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Po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2307-3215-1622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11320" y="1895400"/>
            <a:ext cx="159048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</a:rPr>
              <a:t>HBx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(1374-183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665440" y="3803760"/>
            <a:ext cx="733320" cy="108000"/>
          </a:xfrm>
          <a:prstGeom prst="rect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063960" y="3917880"/>
            <a:ext cx="23004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6610320" y="3903840"/>
            <a:ext cx="252360" cy="10764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543560" y="2533680"/>
            <a:ext cx="1706400" cy="23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nh II (1627-1774)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484360" y="3959280"/>
            <a:ext cx="111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556160" y="2214720"/>
            <a:ext cx="16016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Enh I (1074-123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311640" y="3692520"/>
            <a:ext cx="1093680" cy="108000"/>
          </a:xfrm>
          <a:prstGeom prst="rect">
            <a:avLst/>
          </a:prstGeom>
          <a:blipFill rotWithShape="0">
            <a:blip r:embed="rId2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226040" y="3797280"/>
            <a:ext cx="3073320" cy="1080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608360" y="3689280"/>
            <a:ext cx="1814760" cy="10800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958080" y="3701880"/>
            <a:ext cx="733320" cy="10800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372440" y="3583080"/>
            <a:ext cx="23004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7947000" y="3844800"/>
            <a:ext cx="111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68360" y="1957320"/>
            <a:ext cx="539640" cy="1080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886200" y="2624040"/>
            <a:ext cx="53964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68360" y="2300400"/>
            <a:ext cx="539640" cy="108000"/>
          </a:xfrm>
          <a:prstGeom prst="rect">
            <a:avLst/>
          </a:prstGeom>
          <a:blipFill rotWithShape="0">
            <a:blip r:embed="rId7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68360" y="2620800"/>
            <a:ext cx="539640" cy="108000"/>
          </a:xfrm>
          <a:prstGeom prst="rect">
            <a:avLst/>
          </a:prstGeom>
          <a:blipFill rotWithShape="0">
            <a:blip r:embed="rId8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886200" y="1954080"/>
            <a:ext cx="539640" cy="108000"/>
          </a:xfrm>
          <a:prstGeom prst="rect">
            <a:avLst/>
          </a:prstGeom>
          <a:blipFill rotWithShape="0">
            <a:blip r:embed="rId9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886200" y="2290680"/>
            <a:ext cx="539640" cy="1080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69720" y="3703680"/>
            <a:ext cx="89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BV1.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024360" y="3300480"/>
            <a:ext cx="355320" cy="108000"/>
          </a:xfrm>
          <a:prstGeom prst="rect">
            <a:avLst/>
          </a:prstGeom>
          <a:blipFill rotWithShape="0">
            <a:blip r:embed="rId10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062160" y="3414600"/>
            <a:ext cx="23040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620040" y="3402000"/>
            <a:ext cx="252360" cy="1080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898720" y="3348000"/>
            <a:ext cx="11124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321000" y="3191040"/>
            <a:ext cx="1093680" cy="107640"/>
          </a:xfrm>
          <a:prstGeom prst="rect">
            <a:avLst/>
          </a:prstGeom>
          <a:blipFill rotWithShape="0">
            <a:blip r:embed="rId11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235400" y="3295800"/>
            <a:ext cx="3073320" cy="107640"/>
          </a:xfrm>
          <a:prstGeom prst="rect">
            <a:avLst/>
          </a:prstGeom>
          <a:blipFill rotWithShape="0">
            <a:blip r:embed="rId1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4618080" y="3187800"/>
            <a:ext cx="1814400" cy="108000"/>
          </a:xfrm>
          <a:prstGeom prst="rect">
            <a:avLst/>
          </a:prstGeom>
          <a:blipFill rotWithShape="0">
            <a:blip r:embed="rId1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967440" y="3186000"/>
            <a:ext cx="733680" cy="108000"/>
          </a:xfrm>
          <a:prstGeom prst="rect">
            <a:avLst/>
          </a:prstGeom>
          <a:blipFill rotWithShape="0">
            <a:blip r:embed="rId1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7367760" y="3067200"/>
            <a:ext cx="230040" cy="107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942320" y="3343320"/>
            <a:ext cx="11124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79440" y="3146400"/>
            <a:ext cx="89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BV1.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660760" y="4321080"/>
            <a:ext cx="733320" cy="108000"/>
          </a:xfrm>
          <a:prstGeom prst="rect">
            <a:avLst/>
          </a:prstGeom>
          <a:blipFill rotWithShape="0">
            <a:blip r:embed="rId1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059280" y="4435560"/>
            <a:ext cx="23004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6620040" y="4437000"/>
            <a:ext cx="252360" cy="1080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843200" y="4467240"/>
            <a:ext cx="110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321000" y="4226040"/>
            <a:ext cx="1093680" cy="108000"/>
          </a:xfrm>
          <a:prstGeom prst="rect">
            <a:avLst/>
          </a:prstGeom>
          <a:blipFill rotWithShape="0">
            <a:blip r:embed="rId16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4235400" y="4330800"/>
            <a:ext cx="3073320" cy="108000"/>
          </a:xfrm>
          <a:prstGeom prst="rect">
            <a:avLst/>
          </a:prstGeom>
          <a:blipFill rotWithShape="0">
            <a:blip r:embed="rId17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618080" y="4222800"/>
            <a:ext cx="1814400" cy="108000"/>
          </a:xfrm>
          <a:prstGeom prst="rect">
            <a:avLst/>
          </a:prstGeom>
          <a:blipFill rotWithShape="0">
            <a:blip r:embed="rId18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967440" y="4221000"/>
            <a:ext cx="733680" cy="108000"/>
          </a:xfrm>
          <a:prstGeom prst="rect">
            <a:avLst/>
          </a:prstGeom>
          <a:blipFill rotWithShape="0">
            <a:blip r:embed="rId19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7367760" y="4102200"/>
            <a:ext cx="230040" cy="10800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956720" y="4378320"/>
            <a:ext cx="1108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84120" y="4255920"/>
            <a:ext cx="891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BV1.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959120" y="4424400"/>
            <a:ext cx="1022040" cy="108000"/>
          </a:xfrm>
          <a:prstGeom prst="rect">
            <a:avLst/>
          </a:prstGeom>
          <a:blipFill rotWithShape="0">
            <a:blip r:embed="rId20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308320" y="4530600"/>
            <a:ext cx="252360" cy="10800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7659720" y="4330800"/>
            <a:ext cx="287280" cy="108000"/>
          </a:xfrm>
          <a:prstGeom prst="rect">
            <a:avLst/>
          </a:prstGeom>
          <a:blipFill rotWithShape="0">
            <a:blip r:embed="rId21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7637400" y="3297240"/>
            <a:ext cx="287280" cy="108000"/>
          </a:xfrm>
          <a:prstGeom prst="rect">
            <a:avLst/>
          </a:prstGeom>
          <a:blipFill rotWithShape="0">
            <a:blip r:embed="rId22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7651800" y="3797280"/>
            <a:ext cx="287280" cy="108000"/>
          </a:xfrm>
          <a:prstGeom prst="rect">
            <a:avLst/>
          </a:prstGeom>
          <a:blipFill rotWithShape="0">
            <a:blip r:embed="rId23">
              <a:alphaModFix amt="50000"/>
            </a:blip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603520" y="3903840"/>
            <a:ext cx="324000" cy="107640"/>
          </a:xfrm>
          <a:prstGeom prst="rect">
            <a:avLst/>
          </a:prstGeom>
          <a:blipFill rotWithShape="0">
            <a:blip r:embed="rId2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895400" y="378144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36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281240" y="42750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4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328840" y="31608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65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002440" y="31608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98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8021520" y="366228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98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8021520" y="4181400"/>
            <a:ext cx="63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98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9840" y="757080"/>
            <a:ext cx="402120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Li et al., Additional 1: Figure S1B.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37680" y="1371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"/>
          <p:cNvSpPr/>
          <p:nvPr/>
        </p:nvSpPr>
        <p:spPr>
          <a:xfrm>
            <a:off x="88560" y="757080"/>
            <a:ext cx="443124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Li et al., Additional file 1: Figure S1C.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1"/>
          <a:stretch/>
        </p:blipFill>
        <p:spPr>
          <a:xfrm>
            <a:off x="685800" y="1490760"/>
            <a:ext cx="7238880" cy="5214960"/>
          </a:xfrm>
          <a:prstGeom prst="rect">
            <a:avLst/>
          </a:prstGeom>
          <a:ln w="0">
            <a:noFill/>
          </a:ln>
        </p:spPr>
      </p:pic>
      <p:sp>
        <p:nvSpPr>
          <p:cNvPr id="105" name=""/>
          <p:cNvSpPr/>
          <p:nvPr/>
        </p:nvSpPr>
        <p:spPr>
          <a:xfrm>
            <a:off x="747360" y="12556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2012</cp:lastModifiedBy>
  <dcterms:modified xsi:type="dcterms:W3CDTF">2013-05-30T03:52:55Z</dcterms:modified>
  <cp:revision>30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